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0E42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63" d="100"/>
          <a:sy n="63" d="100"/>
        </p:scale>
        <p:origin x="1308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radarChart>
        <c:radarStyle val="marker"/>
        <c:varyColors val="0"/>
        <c:ser>
          <c:idx val="0"/>
          <c:order val="0"/>
          <c:tx>
            <c:strRef>
              <c:f>Hoja1!$B$1</c:f>
              <c:strCache>
                <c:ptCount val="1"/>
                <c:pt idx="0">
                  <c:v>3-biomarker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0.11666666666666667"/>
                  <c:y val="-9.3749999999999997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1666666666666652"/>
                  <c:y val="-0.05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9.7916666666666666E-2"/>
                  <c:y val="-7.500000000000010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numFmt formatCode="0.0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prstDash val="dash"/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A$2:$A$4</c:f>
              <c:strCache>
                <c:ptCount val="3"/>
                <c:pt idx="0">
                  <c:v>All-cause mortality</c:v>
                </c:pt>
                <c:pt idx="1">
                  <c:v>CV mortality</c:v>
                </c:pt>
                <c:pt idx="2">
                  <c:v>HF mortality</c:v>
                </c:pt>
              </c:strCache>
            </c:strRef>
          </c:cat>
          <c:val>
            <c:numRef>
              <c:f>Hoja1!$B$2:$B$4</c:f>
              <c:numCache>
                <c:formatCode>General</c:formatCode>
                <c:ptCount val="3"/>
                <c:pt idx="0">
                  <c:v>0.78200000000000003</c:v>
                </c:pt>
                <c:pt idx="1">
                  <c:v>0.78600000000000003</c:v>
                </c:pt>
                <c:pt idx="2">
                  <c:v>0.79700000000000004</c:v>
                </c:pt>
              </c:numCache>
            </c:numRef>
          </c:val>
        </c:ser>
        <c:ser>
          <c:idx val="1"/>
          <c:order val="1"/>
          <c:tx>
            <c:strRef>
              <c:f>Hoja1!$C$1</c:f>
              <c:strCache>
                <c:ptCount val="1"/>
                <c:pt idx="0">
                  <c:v>6-biomarker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0.11666666666666667"/>
                  <c:y val="-6.250000000000029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6.6666666666666666E-2"/>
                  <c:y val="-8.749999999999999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6.0416666666666667E-2"/>
                  <c:y val="-0.1000000000000001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numFmt formatCode="0.0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prstDash val="dash"/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A$2:$A$4</c:f>
              <c:strCache>
                <c:ptCount val="3"/>
                <c:pt idx="0">
                  <c:v>All-cause mortality</c:v>
                </c:pt>
                <c:pt idx="1">
                  <c:v>CV mortality</c:v>
                </c:pt>
                <c:pt idx="2">
                  <c:v>HF mortality</c:v>
                </c:pt>
              </c:strCache>
            </c:strRef>
          </c:cat>
          <c:val>
            <c:numRef>
              <c:f>Hoja1!$C$2:$C$4</c:f>
              <c:numCache>
                <c:formatCode>General</c:formatCode>
                <c:ptCount val="3"/>
                <c:pt idx="0">
                  <c:v>0.76800000000000002</c:v>
                </c:pt>
                <c:pt idx="1">
                  <c:v>0.78</c:v>
                </c:pt>
                <c:pt idx="2">
                  <c:v>0.79300000000000004</c:v>
                </c:pt>
              </c:numCache>
            </c:numRef>
          </c:val>
        </c:ser>
        <c:ser>
          <c:idx val="2"/>
          <c:order val="2"/>
          <c:tx>
            <c:strRef>
              <c:f>Hoja1!$D$1</c:f>
              <c:strCache>
                <c:ptCount val="1"/>
                <c:pt idx="0">
                  <c:v>Clinical model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0.12708333333333327"/>
                  <c:y val="3.1249999999999425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4.791666666666667E-2"/>
                  <c:y val="-0.11562500000000001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5.6250000000000001E-2"/>
                  <c:y val="-0.10625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numFmt formatCode="0.0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prstDash val="dash"/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A$2:$A$4</c:f>
              <c:strCache>
                <c:ptCount val="3"/>
                <c:pt idx="0">
                  <c:v>All-cause mortality</c:v>
                </c:pt>
                <c:pt idx="1">
                  <c:v>CV mortality</c:v>
                </c:pt>
                <c:pt idx="2">
                  <c:v>HF mortality</c:v>
                </c:pt>
              </c:strCache>
            </c:strRef>
          </c:cat>
          <c:val>
            <c:numRef>
              <c:f>Hoja1!$D$2:$D$4</c:f>
              <c:numCache>
                <c:formatCode>General</c:formatCode>
                <c:ptCount val="3"/>
                <c:pt idx="0">
                  <c:v>0.752</c:v>
                </c:pt>
                <c:pt idx="1">
                  <c:v>0.77</c:v>
                </c:pt>
                <c:pt idx="2">
                  <c:v>0.78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axId val="419317280"/>
        <c:axId val="419317672"/>
      </c:radarChart>
      <c:catAx>
        <c:axId val="419317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419317672"/>
        <c:crosses val="autoZero"/>
        <c:auto val="1"/>
        <c:lblAlgn val="ctr"/>
        <c:lblOffset val="100"/>
        <c:noMultiLvlLbl val="0"/>
      </c:catAx>
      <c:valAx>
        <c:axId val="419317672"/>
        <c:scaling>
          <c:orientation val="minMax"/>
          <c:max val="0.8"/>
          <c:min val="0.72000000000000008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419317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2205326589056679"/>
          <c:y val="0.85136288011894423"/>
          <c:w val="0.60085713616760672"/>
          <c:h val="5.126179395705003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Subtíto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a-ES" smtClean="0"/>
              <a:t>Feu clic aquí per editar l'estil de subtítols del patró.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2824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7498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0379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contingut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9933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0459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contingut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contingut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5" name="Contenidor de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7372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4" name="Contenidor de contingut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5" name="Contenidor de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6" name="Contenidor de contingut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7" name="Contenidor de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8" name="Contenidor de peu de pà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5554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4" name="Contenidor de peu de pà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3699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3" name="Contenidor de peu de pà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9449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contingut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5" name="Contenidor de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8090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'imatg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5" name="Contenidor de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639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159674-47BB-4CAA-9EAE-671FC26A7C6A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99584-6525-439B-BA97-83FB8F784E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3619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a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Gráfico 15"/>
          <p:cNvGraphicFramePr/>
          <p:nvPr>
            <p:extLst>
              <p:ext uri="{D42A27DB-BD31-4B8C-83A1-F6EECF244321}">
                <p14:modId xmlns:p14="http://schemas.microsoft.com/office/powerpoint/2010/main" val="1128528739"/>
              </p:ext>
            </p:extLst>
          </p:nvPr>
        </p:nvGraphicFramePr>
        <p:xfrm>
          <a:off x="107504" y="908720"/>
          <a:ext cx="8712968" cy="5832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9" name="CuadroTexto 18"/>
          <p:cNvSpPr txBox="1"/>
          <p:nvPr/>
        </p:nvSpPr>
        <p:spPr>
          <a:xfrm>
            <a:off x="453117" y="332656"/>
            <a:ext cx="84555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index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nical, 6-biomarker,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-biomarker model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 outcome</a:t>
            </a:r>
            <a:endParaRPr 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45698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26</Words>
  <Application>Microsoft Office PowerPoint</Application>
  <PresentationFormat>Presentación en pantalla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l'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Andreu Ferrero Gregori</dc:creator>
  <cp:lastModifiedBy>Jesús Álvarez García</cp:lastModifiedBy>
  <cp:revision>25</cp:revision>
  <dcterms:created xsi:type="dcterms:W3CDTF">2018-10-23T14:39:25Z</dcterms:created>
  <dcterms:modified xsi:type="dcterms:W3CDTF">2019-10-03T20:07:58Z</dcterms:modified>
</cp:coreProperties>
</file>